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4660"/>
  </p:normalViewPr>
  <p:slideViewPr>
    <p:cSldViewPr snapToGrid="0">
      <p:cViewPr varScale="1">
        <p:scale>
          <a:sx n="75" d="100"/>
          <a:sy n="75" d="100"/>
        </p:scale>
        <p:origin x="34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35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103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95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264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64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25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169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883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709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1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781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720E2-1CF3-43E3-BDAA-3934EAB0517F}" type="datetimeFigureOut">
              <a:rPr lang="en-US" smtClean="0"/>
              <a:t>6/2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7F224-B365-4E86-A00E-D216A935E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297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7227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92172" y="840879"/>
            <a:ext cx="7342629" cy="2674046"/>
            <a:chOff x="103888" y="840879"/>
            <a:chExt cx="7798215" cy="2674046"/>
          </a:xfrm>
        </p:grpSpPr>
        <p:graphicFrame>
          <p:nvGraphicFramePr>
            <p:cNvPr id="22" name="Object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36487770"/>
                </p:ext>
              </p:extLst>
            </p:nvPr>
          </p:nvGraphicFramePr>
          <p:xfrm>
            <a:off x="130694" y="1228925"/>
            <a:ext cx="385652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526" name="Prism 9" r:id="rId3" imgW="4166770" imgH="2469936" progId="Prism9.Document">
                    <p:embed/>
                  </p:oleObj>
                </mc:Choice>
                <mc:Fallback>
                  <p:oleObj name="Prism 9" r:id="rId3" imgW="4166770" imgH="2469936" progId="Prism9.Document">
                    <p:embed/>
                    <p:pic>
                      <p:nvPicPr>
                        <p:cNvPr id="22" name="Object 2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0694" y="1228925"/>
                          <a:ext cx="385652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4087424" y="840879"/>
              <a:ext cx="2718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3888" y="840879"/>
              <a:ext cx="2718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21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7074155"/>
                </p:ext>
              </p:extLst>
            </p:nvPr>
          </p:nvGraphicFramePr>
          <p:xfrm>
            <a:off x="4163526" y="1228925"/>
            <a:ext cx="3738577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527" name="Prism 9" r:id="rId5" imgW="4015873" imgH="2456251" progId="Prism9.Document">
                    <p:embed/>
                  </p:oleObj>
                </mc:Choice>
                <mc:Fallback>
                  <p:oleObj name="Prism 9" r:id="rId5" imgW="4015873" imgH="2456251" progId="Prism9.Document">
                    <p:embed/>
                    <p:pic>
                      <p:nvPicPr>
                        <p:cNvPr id="21" name="Object 20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163526" y="1228925"/>
                          <a:ext cx="3738577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5E642000-406D-184C-BA9F-3DF107B32986}"/>
              </a:ext>
            </a:extLst>
          </p:cNvPr>
          <p:cNvSpPr/>
          <p:nvPr/>
        </p:nvSpPr>
        <p:spPr>
          <a:xfrm>
            <a:off x="685800" y="4085736"/>
            <a:ext cx="6400800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he effect of oxalate on THP-1 macrophage anti-bacterial response to CFT073 exposure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Cell lysates (intracellular) and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cellular media (extracellular) were plated on LB plates to estimate the bacterial burden (CFU/ml) in THP-1 macrophages exposed to oxalate and CFT073. All experiments were performed at least three times with n=5 individual experiments. Data are expressed as mean ± SEM. *p&lt;0.05, **p&lt;0.01 is significant compared to control THP-1 macrophages.</a:t>
            </a:r>
          </a:p>
          <a:p>
            <a:pPr>
              <a:spcBef>
                <a:spcPts val="600"/>
              </a:spcBef>
              <a:spcAft>
                <a:spcPts val="1200"/>
              </a:spcAft>
            </a:pP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8350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52</TotalTime>
  <Words>103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Parveen (Campus)</dc:creator>
  <cp:lastModifiedBy>Mitchell, Tanecia (Campus)</cp:lastModifiedBy>
  <cp:revision>132</cp:revision>
  <dcterms:created xsi:type="dcterms:W3CDTF">2020-11-11T18:03:42Z</dcterms:created>
  <dcterms:modified xsi:type="dcterms:W3CDTF">2021-06-28T19:00:40Z</dcterms:modified>
</cp:coreProperties>
</file>